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55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D36B684-D74E-4135-A607-5129EC6E19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8EE416B7-A63A-4111-9591-394215EC0B8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8F78AE2C-F5A3-4419-BE9F-2F07FCE71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7FB12E3-AC11-4B4C-8213-6DCAE33C5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FD70623F-59D5-4B68-85B0-4706DC7EF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785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269C39FC-0C9E-4D69-8C99-109C58DB49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0EAEC70-136D-4B5D-B831-6B71BBC6E5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C74A9A0C-BF0C-4F68-9A4D-28175A9B30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D4E6D1A-0BA6-4F26-91E1-65E88F6186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E5DCD7BA-E2A4-4496-981B-2C45F2882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02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CDA3D5DA-6F3F-4C8C-A62C-27413C5E97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4716FC49-FEEC-4609-AC3F-733FD6153E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1069FBB-D4C0-48DA-BCD7-95DFAC102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79E14B5-3965-4C7D-863B-3ACEB9CB1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971DCAF-E99F-4CC0-8EC1-7A4C52A13E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0669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CCE5C7F0-0EE9-4BA3-A6D7-44EE013D8B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02092B3C-D2E3-426E-AC6E-46D3D42C8C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2A70D3D5-F519-4EBC-B38C-A3C8F9C59A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018FB7F8-4DBE-4BA4-8C51-DCAE6AC93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3E807EE-B2DB-41A0-A974-46B366E2AD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71929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7F38D831-FAA0-4BD2-B8BF-09BDCDA567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8882271F-311C-44F2-8AEA-C6BEDEA98D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FC10A58-A6F9-4605-A771-066BEB0D4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E7AD6B-3D94-49A2-995E-0299794CD1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648DAD5-EC24-4007-85DF-8D1D87BD7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7612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BD29318F-EA23-45ED-9333-5A0D16DD2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2059D68D-55D8-4D18-B23E-242AED7155C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3CB35A66-1CBB-4464-8482-B8F8072D737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53D60BB6-1C68-4D05-BF9E-8E69F3DC49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564063BE-FAA7-48CF-857C-D768D9EE3F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54A383B8-6432-441B-8B4A-127B49B777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6351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FF8FB2C-F240-4A4A-8BF6-E97AB6933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2217F7DF-7014-4081-83A6-10127BB2A2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EEB2FE28-BCC7-416B-BE31-BED6C53C767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CC62E9FF-CFAB-4DEE-8F0C-5E0FF67E0C8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AFB7A299-682C-40B2-976F-D79613DB49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AD06DE15-6D10-4FAE-B6AF-0C0FF4048A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7560E965-EC8E-46F9-B8DC-BE9C48DC4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35537008-541E-4A72-98D7-D44CA81445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00907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4C01D835-FA63-437E-8DD3-D46AD4E383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66711B21-ACE3-4158-B441-03351B87B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328D6DE-852D-4F8C-BBBE-C2BA79A70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72C240B2-C1C3-42E6-A2A8-9E4424C035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0138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4D306D45-511E-4676-9627-55AA62F05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F5C011B2-D8F6-4140-9625-4A6891905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59F55D1D-B575-43AE-A2EF-E2CE94D24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91552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A3D088F-F2EB-49D8-8C95-43108320B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211F8027-3B79-499F-B591-D9C5CD7FE0E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DDE820F0-9239-4641-BD94-4DDAF2820B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F019E457-B969-4F2D-92C2-A5834A37E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15197713-0B38-46FF-87CF-9A144394B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E7C123EA-B3C0-4027-9758-1A8E97226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4527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7E6CB0B-62A9-4C28-B2B8-0FDC6A63FE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27C059CF-10B3-4F90-BFF8-CA000694C54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3B6CBCBF-42CC-4FD7-BD6F-296F3FFA25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E8BDB99E-E832-43EC-AC9E-10F469E618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4999BEC-A81A-4A6F-A0D1-21B0374FE9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61EE7A6E-AFA0-46A0-BA9A-EEB14BC9C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702826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C3A74913-CB06-4AF6-B5A8-42266D905F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804D80F4-6450-4613-90B3-D9C9380F6C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0C4A5BE1-93D4-48B4-A9A8-325C60C159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60D63-69F9-4C42-9198-2FD01798A751}" type="datetimeFigureOut">
              <a:rPr lang="zh-CN" altLang="en-US" smtClean="0"/>
              <a:t>2018/11/11 Sun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E85FE409-9EB5-4E3E-8C24-B6503621E2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80DE2126-6306-4744-B1C3-8F1236503F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D5D67-8D2F-4DF1-8793-FC1DC3B8915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6548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xmlns="" id="{3C3DBF4E-D314-49EE-96DA-F7F1CA6A57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78585" y="166977"/>
            <a:ext cx="8829672" cy="5707684"/>
          </a:xfrm>
          <a:prstGeom prst="rect">
            <a:avLst/>
          </a:prstGeom>
        </p:spPr>
      </p:pic>
      <p:sp>
        <p:nvSpPr>
          <p:cNvPr id="3" name="矩形 2">
            <a:extLst>
              <a:ext uri="{FF2B5EF4-FFF2-40B4-BE49-F238E27FC236}">
                <a16:creationId xmlns:a16="http://schemas.microsoft.com/office/drawing/2014/main" xmlns="" id="{942D3764-CEDE-465B-A84F-32505924FE36}"/>
              </a:ext>
            </a:extLst>
          </p:cNvPr>
          <p:cNvSpPr/>
          <p:nvPr/>
        </p:nvSpPr>
        <p:spPr>
          <a:xfrm>
            <a:off x="2858575" y="5956574"/>
            <a:ext cx="680300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3 Fig. KEGG pathway analysis identified phenylalanine metabolism (ko00360) for DEGs between 5 DAP and 14DAP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, green and blue indicate genes expression increase, decrease and mixed change at 14 DAP, respectively</a:t>
            </a:r>
            <a:r>
              <a:rPr lang="en-US" altLang="zh-CN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zh-CN" sz="10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5127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40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ngyang</dc:creator>
  <cp:lastModifiedBy>微软用户</cp:lastModifiedBy>
  <cp:revision>11</cp:revision>
  <dcterms:created xsi:type="dcterms:W3CDTF">2018-10-07T03:25:32Z</dcterms:created>
  <dcterms:modified xsi:type="dcterms:W3CDTF">2018-11-11T14:47:20Z</dcterms:modified>
</cp:coreProperties>
</file>